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816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79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058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643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365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156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68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17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555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861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197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3CDB0-40C7-4E79-948B-DA4ED88FFA41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89D6F-993E-4080-81F0-AB14E3370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885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5731343"/>
              </p:ext>
            </p:extLst>
          </p:nvPr>
        </p:nvGraphicFramePr>
        <p:xfrm>
          <a:off x="4298589" y="1704877"/>
          <a:ext cx="3603299" cy="401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1057">
                  <a:extLst>
                    <a:ext uri="{9D8B030D-6E8A-4147-A177-3AD203B41FA5}">
                      <a16:colId xmlns:a16="http://schemas.microsoft.com/office/drawing/2014/main" val="1694706532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val="4290989965"/>
                    </a:ext>
                  </a:extLst>
                </a:gridCol>
                <a:gridCol w="801188">
                  <a:extLst>
                    <a:ext uri="{9D8B030D-6E8A-4147-A177-3AD203B41FA5}">
                      <a16:colId xmlns:a16="http://schemas.microsoft.com/office/drawing/2014/main" val="4086517563"/>
                    </a:ext>
                  </a:extLst>
                </a:gridCol>
                <a:gridCol w="813111">
                  <a:extLst>
                    <a:ext uri="{9D8B030D-6E8A-4147-A177-3AD203B41FA5}">
                      <a16:colId xmlns:a16="http://schemas.microsoft.com/office/drawing/2014/main" val="2243525773"/>
                    </a:ext>
                  </a:extLst>
                </a:gridCol>
              </a:tblGrid>
              <a:tr h="667472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Number of plants inspected across a transe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Average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</a:rPr>
                        <a:t> number of whiteflies observ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Standard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</a:rPr>
                        <a:t> deviation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Standard error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6398303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9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6,85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-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7433814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6,69333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3,13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7,31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6368654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2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6,9544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3,4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,24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9660667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b="1" dirty="0">
                          <a:solidFill>
                            <a:srgbClr val="FF0000"/>
                          </a:solidFill>
                        </a:rPr>
                        <a:t>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solidFill>
                            <a:srgbClr val="FF0000"/>
                          </a:solidFill>
                        </a:rPr>
                        <a:t>56,7433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solidFill>
                            <a:srgbClr val="FF0000"/>
                          </a:solidFill>
                        </a:rPr>
                        <a:t>4,90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solidFill>
                            <a:srgbClr val="FF0000"/>
                          </a:solidFill>
                        </a:rPr>
                        <a:t>1,55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2399716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4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6,522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6,1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,93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442021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4,91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,5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,11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1498174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6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6,0916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,53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,117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9322270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7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5,3271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,88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,22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6907353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8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7,7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,86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,90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2102335"/>
                  </a:ext>
                </a:extLst>
              </a:tr>
              <a:tr h="301280">
                <a:tc>
                  <a:txBody>
                    <a:bodyPr/>
                    <a:lstStyle/>
                    <a:p>
                      <a:r>
                        <a:rPr lang="en-US" sz="1200" dirty="0"/>
                        <a:t>9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57,47444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,13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,67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3881198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2461386"/>
              </p:ext>
            </p:extLst>
          </p:nvPr>
        </p:nvGraphicFramePr>
        <p:xfrm>
          <a:off x="8152019" y="1738600"/>
          <a:ext cx="3603300" cy="11851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54637">
                  <a:extLst>
                    <a:ext uri="{9D8B030D-6E8A-4147-A177-3AD203B41FA5}">
                      <a16:colId xmlns:a16="http://schemas.microsoft.com/office/drawing/2014/main" val="3807924332"/>
                    </a:ext>
                  </a:extLst>
                </a:gridCol>
                <a:gridCol w="1848663">
                  <a:extLst>
                    <a:ext uri="{9D8B030D-6E8A-4147-A177-3AD203B41FA5}">
                      <a16:colId xmlns:a16="http://schemas.microsoft.com/office/drawing/2014/main" val="1648332413"/>
                    </a:ext>
                  </a:extLst>
                </a:gridCol>
              </a:tblGrid>
              <a:tr h="363986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Mean time/field (in seconds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48,16667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7398291"/>
                  </a:ext>
                </a:extLst>
              </a:tr>
              <a:tr h="363986">
                <a:tc>
                  <a:txBody>
                    <a:bodyPr/>
                    <a:lstStyle/>
                    <a:p>
                      <a:r>
                        <a:rPr lang="en-US" sz="1200" dirty="0"/>
                        <a:t>Mean x 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445 sec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8697998"/>
                  </a:ext>
                </a:extLst>
              </a:tr>
              <a:tr h="363986">
                <a:tc>
                  <a:txBody>
                    <a:bodyPr/>
                    <a:lstStyle/>
                    <a:p>
                      <a:r>
                        <a:rPr lang="en-US" sz="1200" dirty="0"/>
                        <a:t>Total time per fiel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4,08333 min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9419998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755743" y="4941608"/>
            <a:ext cx="26883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 = 99 plants</a:t>
            </a:r>
          </a:p>
          <a:p>
            <a:r>
              <a:rPr lang="en-US" dirty="0"/>
              <a:t>X = 56,85 adults/leaf/plan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44732" y="365760"/>
            <a:ext cx="4732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</a:t>
            </a:r>
            <a:r>
              <a:rPr lang="en-US" b="1"/>
              <a:t>Figure S1 </a:t>
            </a:r>
            <a:r>
              <a:rPr lang="en-US" b="1" dirty="0"/>
              <a:t>- Field survey protoco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44732" y="1693348"/>
            <a:ext cx="3100250" cy="2896864"/>
          </a:xfrm>
          <a:prstGeom prst="rect">
            <a:avLst/>
          </a:prstGeom>
          <a:noFill/>
          <a:ln w="38100">
            <a:solidFill>
              <a:srgbClr val="92D05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1005586" y="1909848"/>
            <a:ext cx="2778542" cy="2565126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 rot="19051875">
            <a:off x="1512143" y="2739106"/>
            <a:ext cx="16741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99 observations</a:t>
            </a:r>
          </a:p>
        </p:txBody>
      </p:sp>
      <p:sp>
        <p:nvSpPr>
          <p:cNvPr id="13" name="TextBox 12"/>
          <p:cNvSpPr txBox="1"/>
          <p:nvPr/>
        </p:nvSpPr>
        <p:spPr>
          <a:xfrm rot="19002776">
            <a:off x="1759009" y="3046516"/>
            <a:ext cx="16741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30 observation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49221" y="4670910"/>
            <a:ext cx="3299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 ha cassava field = 10,000 plant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85107" y="1243318"/>
            <a:ext cx="2163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eld data collection desig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298589" y="1243318"/>
            <a:ext cx="35589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etermining the number of observations/fiel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152019" y="1243317"/>
            <a:ext cx="30747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ime required to inspect 30 plants/field</a:t>
            </a:r>
          </a:p>
        </p:txBody>
      </p:sp>
    </p:spTree>
    <p:extLst>
      <p:ext uri="{BB962C8B-B14F-4D97-AF65-F5344CB8AC3E}">
        <p14:creationId xmlns:p14="http://schemas.microsoft.com/office/powerpoint/2010/main" val="3861048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25</Words>
  <Application>Microsoft Office PowerPoint</Application>
  <PresentationFormat>Widescreen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ellar, Wilmer (Alliance Bioversity-CIAT)</dc:creator>
  <cp:lastModifiedBy>MDPI</cp:lastModifiedBy>
  <cp:revision>8</cp:revision>
  <dcterms:created xsi:type="dcterms:W3CDTF">2022-09-01T01:18:00Z</dcterms:created>
  <dcterms:modified xsi:type="dcterms:W3CDTF">2022-09-22T09:16:25Z</dcterms:modified>
</cp:coreProperties>
</file>